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94549"/>
  </p:normalViewPr>
  <p:slideViewPr>
    <p:cSldViewPr snapToGrid="0" snapToObjects="1">
      <p:cViewPr>
        <p:scale>
          <a:sx n="119" d="100"/>
          <a:sy n="119" d="100"/>
        </p:scale>
        <p:origin x="-8" y="-8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277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63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504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40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663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918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070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427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704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52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482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9C8F2-2A48-7F4A-9C28-DDE48B008BD2}" type="datetimeFigureOut">
              <a:rPr lang="en-US" smtClean="0"/>
              <a:t>6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7E27A-CEA1-F34C-A08B-377A2E8FF2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789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2595" y="250094"/>
            <a:ext cx="1065393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200" dirty="0" smtClean="0">
                <a:effectLst/>
                <a:latin typeface="Arial" charset="0"/>
                <a:ea typeface="Arial" charset="0"/>
                <a:cs typeface="Arial" charset="0"/>
              </a:rPr>
              <a:t>Screenshot of the smartphone version of our Internet support group homepage.</a:t>
            </a:r>
            <a:endParaRPr lang="en-US" sz="22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700338" y="896820"/>
            <a:ext cx="6710949" cy="5460398"/>
            <a:chOff x="2700338" y="896820"/>
            <a:chExt cx="6710949" cy="5460398"/>
          </a:xfrm>
        </p:grpSpPr>
        <p:grpSp>
          <p:nvGrpSpPr>
            <p:cNvPr id="6" name="Group 5"/>
            <p:cNvGrpSpPr/>
            <p:nvPr/>
          </p:nvGrpSpPr>
          <p:grpSpPr>
            <a:xfrm>
              <a:off x="2700338" y="896820"/>
              <a:ext cx="6710949" cy="5460398"/>
              <a:chOff x="990600" y="1371600"/>
              <a:chExt cx="6710949" cy="5334000"/>
            </a:xfrm>
          </p:grpSpPr>
          <p:pic>
            <p:nvPicPr>
              <p:cNvPr id="7" name="Picture 6" descr="C:\Users\belnapbh\AppData\Local\Microsoft\Windows\Temporary Internet Files\Content.Outlook\4AZ2NOZ5\photo (3).PN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780" r="2239" b="16331"/>
              <a:stretch/>
            </p:blipFill>
            <p:spPr bwMode="auto">
              <a:xfrm>
                <a:off x="4191001" y="1371600"/>
                <a:ext cx="3510548" cy="533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90600" y="1371600"/>
                <a:ext cx="3200400" cy="533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" name="Rectangle 1"/>
            <p:cNvSpPr/>
            <p:nvPr/>
          </p:nvSpPr>
          <p:spPr>
            <a:xfrm>
              <a:off x="7179879" y="4461641"/>
              <a:ext cx="299545" cy="1261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7179878" y="5581781"/>
              <a:ext cx="299545" cy="1261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338037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2595" y="250094"/>
            <a:ext cx="1065393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200" dirty="0" smtClean="0">
                <a:effectLst/>
                <a:latin typeface="Arial" charset="0"/>
                <a:ea typeface="Arial" charset="0"/>
                <a:cs typeface="Arial" charset="0"/>
              </a:rPr>
              <a:t>Screenshot of our Internet support group discussion boards.</a:t>
            </a:r>
            <a:endParaRPr lang="en-US" sz="22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6456" y="898123"/>
            <a:ext cx="611524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7410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2595" y="250094"/>
            <a:ext cx="1065393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200" dirty="0" smtClean="0">
                <a:effectLst/>
                <a:latin typeface="Arial" charset="0"/>
                <a:ea typeface="Arial" charset="0"/>
                <a:cs typeface="Arial" charset="0"/>
              </a:rPr>
              <a:t>Screenshot of a member profile page on our Internet support group.</a:t>
            </a:r>
            <a:endParaRPr lang="en-US" sz="22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225" y="897298"/>
            <a:ext cx="6721993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0929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3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Rosenberger</dc:creator>
  <cp:lastModifiedBy>Emily Rosenberger</cp:lastModifiedBy>
  <cp:revision>6</cp:revision>
  <dcterms:created xsi:type="dcterms:W3CDTF">2018-03-14T16:32:04Z</dcterms:created>
  <dcterms:modified xsi:type="dcterms:W3CDTF">2018-06-14T16:46:56Z</dcterms:modified>
</cp:coreProperties>
</file>